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  <p:sldId id="258" r:id="rId3"/>
  </p:sldIdLst>
  <p:sldSz cx="12192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1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 dirty="0">
                <a:effectLst/>
              </a:rPr>
              <a:t>Down-regulated genes in RTx2911 after </a:t>
            </a:r>
            <a:r>
              <a:rPr lang="en-US" sz="1400" b="1" i="0" baseline="0" dirty="0" err="1">
                <a:effectLst/>
              </a:rPr>
              <a:t>innoculation</a:t>
            </a:r>
            <a:endParaRPr lang="en-US" sz="14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MolecularFunction!$K$8:$K$22</c:f>
              <c:strCache>
                <c:ptCount val="15"/>
                <c:pt idx="0">
                  <c:v>Fatty acid alpha-hydroxylase activity </c:v>
                </c:pt>
                <c:pt idx="1">
                  <c:v>Small molecule binding </c:v>
                </c:pt>
                <c:pt idx="2">
                  <c:v>L-malate dehydrogenase activity </c:v>
                </c:pt>
                <c:pt idx="3">
                  <c:v>Inorganic anion exchanger activity </c:v>
                </c:pt>
                <c:pt idx="4">
                  <c:v>MRNA binding </c:v>
                </c:pt>
                <c:pt idx="5">
                  <c:v>Structural constituent of ribosome </c:v>
                </c:pt>
                <c:pt idx="6">
                  <c:v>Phosphoric ester hydrolase activity </c:v>
                </c:pt>
                <c:pt idx="7">
                  <c:v>Malate dehydrogenase (NADP+) activity </c:v>
                </c:pt>
                <c:pt idx="8">
                  <c:v>Anion binding </c:v>
                </c:pt>
                <c:pt idx="9">
                  <c:v>Phosphoric diester hydrolase activity </c:v>
                </c:pt>
                <c:pt idx="10">
                  <c:v>NADP binding </c:v>
                </c:pt>
                <c:pt idx="11">
                  <c:v>Nucleoside kinase activity </c:v>
                </c:pt>
                <c:pt idx="12">
                  <c:v>Oxidoreductase activity </c:v>
                </c:pt>
                <c:pt idx="13">
                  <c:v>Cofactor binding </c:v>
                </c:pt>
                <c:pt idx="14">
                  <c:v>Chlorophyll binding </c:v>
                </c:pt>
              </c:strCache>
            </c:strRef>
          </c:cat>
          <c:val>
            <c:numRef>
              <c:f>MolecularFunction!$L$8:$L$22</c:f>
              <c:numCache>
                <c:formatCode>General</c:formatCode>
                <c:ptCount val="15"/>
                <c:pt idx="0">
                  <c:v>2</c:v>
                </c:pt>
                <c:pt idx="1">
                  <c:v>114</c:v>
                </c:pt>
                <c:pt idx="2">
                  <c:v>3</c:v>
                </c:pt>
                <c:pt idx="3">
                  <c:v>2</c:v>
                </c:pt>
                <c:pt idx="4">
                  <c:v>9</c:v>
                </c:pt>
                <c:pt idx="5">
                  <c:v>20</c:v>
                </c:pt>
                <c:pt idx="6">
                  <c:v>19</c:v>
                </c:pt>
                <c:pt idx="7">
                  <c:v>2</c:v>
                </c:pt>
                <c:pt idx="8">
                  <c:v>115</c:v>
                </c:pt>
                <c:pt idx="9">
                  <c:v>7</c:v>
                </c:pt>
                <c:pt idx="10">
                  <c:v>9</c:v>
                </c:pt>
                <c:pt idx="11">
                  <c:v>7</c:v>
                </c:pt>
                <c:pt idx="12">
                  <c:v>76</c:v>
                </c:pt>
                <c:pt idx="13">
                  <c:v>57</c:v>
                </c:pt>
                <c:pt idx="1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0D-46C8-B103-97562D8D20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396562632"/>
        <c:axId val="396562304"/>
      </c:barChart>
      <c:catAx>
        <c:axId val="396562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6562304"/>
        <c:crosses val="autoZero"/>
        <c:auto val="1"/>
        <c:lblAlgn val="ctr"/>
        <c:lblOffset val="100"/>
        <c:noMultiLvlLbl val="0"/>
      </c:catAx>
      <c:valAx>
        <c:axId val="3965623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6562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 dirty="0">
                <a:effectLst/>
              </a:rPr>
              <a:t>Up-regulated genes in RTx2911 after </a:t>
            </a:r>
            <a:r>
              <a:rPr lang="en-US" sz="1400" b="1" i="0" baseline="0" dirty="0" err="1">
                <a:effectLst/>
              </a:rPr>
              <a:t>inocculation</a:t>
            </a:r>
            <a:endParaRPr lang="en-US" sz="1400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5949848423782571"/>
          <c:y val="0.12046876742289936"/>
          <c:w val="0.60157788385650579"/>
          <c:h val="0.7717514508639712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MolecularFunction!$E$7:$E$25</c:f>
              <c:strCache>
                <c:ptCount val="19"/>
                <c:pt idx="0">
                  <c:v>Transmembrane transporter activity </c:v>
                </c:pt>
                <c:pt idx="1">
                  <c:v>Transcription regulator activity </c:v>
                </c:pt>
                <c:pt idx="2">
                  <c:v>Purine NTP binding</c:v>
                </c:pt>
                <c:pt idx="3">
                  <c:v>Protein kinase activity </c:v>
                </c:pt>
                <c:pt idx="4">
                  <c:v>DNA-binding transcription factor activity </c:v>
                </c:pt>
                <c:pt idx="5">
                  <c:v>Carbohydrate derivative binding </c:v>
                </c:pt>
                <c:pt idx="6">
                  <c:v>Sequence-specific DNA binding </c:v>
                </c:pt>
                <c:pt idx="7">
                  <c:v>Endoxyloglucan transferase activity</c:v>
                </c:pt>
                <c:pt idx="8">
                  <c:v>Drug binding </c:v>
                </c:pt>
                <c:pt idx="9">
                  <c:v>Catalytic activity, acting on a protein </c:v>
                </c:pt>
                <c:pt idx="10">
                  <c:v>DNA binding </c:v>
                </c:pt>
                <c:pt idx="11">
                  <c:v>Phenylalanine ammonia-lyase activity </c:v>
                </c:pt>
                <c:pt idx="12">
                  <c:v>Dioxygenase activity </c:v>
                </c:pt>
                <c:pt idx="13">
                  <c:v>Acidic amino acid transporter activity</c:v>
                </c:pt>
                <c:pt idx="14">
                  <c:v>Organic acid transporter activity </c:v>
                </c:pt>
                <c:pt idx="15">
                  <c:v>Hydrolase activity </c:v>
                </c:pt>
                <c:pt idx="16">
                  <c:v>Naringenin-chalcone synthase activity </c:v>
                </c:pt>
                <c:pt idx="17">
                  <c:v>Oxidoreductase activity </c:v>
                </c:pt>
                <c:pt idx="18">
                  <c:v>Cofactor binding </c:v>
                </c:pt>
              </c:strCache>
            </c:strRef>
          </c:cat>
          <c:val>
            <c:numRef>
              <c:f>MolecularFunction!$F$7:$F$25</c:f>
              <c:numCache>
                <c:formatCode>General</c:formatCode>
                <c:ptCount val="19"/>
                <c:pt idx="0">
                  <c:v>52</c:v>
                </c:pt>
                <c:pt idx="1">
                  <c:v>40</c:v>
                </c:pt>
                <c:pt idx="2">
                  <c:v>105</c:v>
                </c:pt>
                <c:pt idx="3">
                  <c:v>69</c:v>
                </c:pt>
                <c:pt idx="4">
                  <c:v>37</c:v>
                </c:pt>
                <c:pt idx="5">
                  <c:v>122</c:v>
                </c:pt>
                <c:pt idx="6">
                  <c:v>29</c:v>
                </c:pt>
                <c:pt idx="7">
                  <c:v>5</c:v>
                </c:pt>
                <c:pt idx="8">
                  <c:v>103</c:v>
                </c:pt>
                <c:pt idx="9">
                  <c:v>114</c:v>
                </c:pt>
                <c:pt idx="10">
                  <c:v>81</c:v>
                </c:pt>
                <c:pt idx="11">
                  <c:v>3</c:v>
                </c:pt>
                <c:pt idx="12">
                  <c:v>8</c:v>
                </c:pt>
                <c:pt idx="13">
                  <c:v>10</c:v>
                </c:pt>
                <c:pt idx="14">
                  <c:v>11</c:v>
                </c:pt>
                <c:pt idx="15">
                  <c:v>141</c:v>
                </c:pt>
                <c:pt idx="16">
                  <c:v>4</c:v>
                </c:pt>
                <c:pt idx="17">
                  <c:v>88</c:v>
                </c:pt>
                <c:pt idx="18">
                  <c:v>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20-447D-AA08-D60136A3ED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325071864"/>
        <c:axId val="325071536"/>
      </c:barChart>
      <c:catAx>
        <c:axId val="3250718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071536"/>
        <c:crosses val="autoZero"/>
        <c:auto val="1"/>
        <c:lblAlgn val="ctr"/>
        <c:lblOffset val="100"/>
        <c:noMultiLvlLbl val="0"/>
      </c:catAx>
      <c:valAx>
        <c:axId val="3250715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071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6836"/>
            <a:ext cx="103632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2446"/>
            <a:ext cx="91440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651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347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150"/>
            <a:ext cx="262890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150"/>
            <a:ext cx="7734300" cy="697420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156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01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1688"/>
            <a:ext cx="1051560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07358"/>
            <a:ext cx="1051560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875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795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152"/>
            <a:ext cx="105156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17396"/>
            <a:ext cx="5157787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06090"/>
            <a:ext cx="5157787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17396"/>
            <a:ext cx="518318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06090"/>
            <a:ext cx="5183188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39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582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75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4912"/>
            <a:ext cx="617220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233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4912"/>
            <a:ext cx="617220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87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152"/>
            <a:ext cx="105156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0750"/>
            <a:ext cx="105156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27622"/>
            <a:ext cx="41148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04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3E2455-AB72-4B24-B1F2-9F516DFB2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7930" y="2190750"/>
            <a:ext cx="11618844" cy="21990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000" b="1" dirty="0">
                <a:solidFill>
                  <a:srgbClr val="21212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criptome analysis of early stages of sorghum grain mold disease reveals defense regulators and metabolic pathways associated with resistance</a:t>
            </a:r>
          </a:p>
          <a:p>
            <a:pPr marL="0" indent="0" algn="ctr">
              <a:lnSpc>
                <a:spcPct val="150000"/>
              </a:lnSpc>
              <a:buNone/>
            </a:pPr>
            <a:endParaRPr lang="en-US" sz="2000" dirty="0"/>
          </a:p>
          <a:p>
            <a:pPr marL="0" indent="0" algn="ctr">
              <a:lnSpc>
                <a:spcPct val="150000"/>
              </a:lnSpc>
              <a:buNone/>
            </a:pPr>
            <a:r>
              <a:rPr lang="en-US" sz="2000" dirty="0"/>
              <a:t>Habte Nida, Sanghun Lee, Ying Li, Tesfaye Mengiste</a:t>
            </a:r>
          </a:p>
        </p:txBody>
      </p:sp>
    </p:spTree>
    <p:extLst>
      <p:ext uri="{BB962C8B-B14F-4D97-AF65-F5344CB8AC3E}">
        <p14:creationId xmlns:p14="http://schemas.microsoft.com/office/powerpoint/2010/main" val="134552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0181078"/>
              </p:ext>
            </p:extLst>
          </p:nvPr>
        </p:nvGraphicFramePr>
        <p:xfrm>
          <a:off x="6505506" y="1991063"/>
          <a:ext cx="5640918" cy="4138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3957266"/>
              </p:ext>
            </p:extLst>
          </p:nvPr>
        </p:nvGraphicFramePr>
        <p:xfrm>
          <a:off x="275166" y="2041639"/>
          <a:ext cx="5820834" cy="3910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359421" y="1774935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721552" y="1774935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9309" y="538144"/>
            <a:ext cx="14205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3778571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4</TotalTime>
  <Words>53</Words>
  <Application>Microsoft Office PowerPoint</Application>
  <PresentationFormat>Custom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Purdue University - Ag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bte Nida Chikssa</dc:creator>
  <cp:lastModifiedBy>Mengiste, Tesfaye</cp:lastModifiedBy>
  <cp:revision>23</cp:revision>
  <dcterms:created xsi:type="dcterms:W3CDTF">2020-10-05T21:04:59Z</dcterms:created>
  <dcterms:modified xsi:type="dcterms:W3CDTF">2021-02-09T14:46:21Z</dcterms:modified>
</cp:coreProperties>
</file>